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99" r:id="rId2"/>
    <p:sldId id="298" r:id="rId3"/>
    <p:sldId id="301" r:id="rId4"/>
    <p:sldId id="302" r:id="rId5"/>
    <p:sldId id="303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62" userDrawn="1">
          <p15:clr>
            <a:srgbClr val="A4A3A4"/>
          </p15:clr>
        </p15:guide>
        <p15:guide id="2" pos="209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rina green" initials="kg" lastIdx="15" clrIdx="0"/>
  <p:cmAuthor id="2" name="Jeremy Lum" initials="JL" lastIdx="1" clrIdx="1"/>
  <p:cmAuthor id="3" name="Yinghua Yu" initials="YY" lastIdx="0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C981C"/>
    <a:srgbClr val="50A096"/>
    <a:srgbClr val="CC00CC"/>
    <a:srgbClr val="FF00FF"/>
    <a:srgbClr val="616778"/>
    <a:srgbClr val="2B8313"/>
    <a:srgbClr val="FF9900"/>
    <a:srgbClr val="FDF731"/>
    <a:srgbClr val="8E94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9" autoAdjust="0"/>
    <p:restoredTop sz="92548" autoAdjust="0"/>
  </p:normalViewPr>
  <p:slideViewPr>
    <p:cSldViewPr snapToGrid="0">
      <p:cViewPr>
        <p:scale>
          <a:sx n="100" d="100"/>
          <a:sy n="100" d="100"/>
        </p:scale>
        <p:origin x="1004" y="48"/>
      </p:cViewPr>
      <p:guideLst>
        <p:guide orient="horz" pos="2562"/>
        <p:guide pos="2092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image" Target="../media/image2.emf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571935-1114-4F14-9130-B4A84FB21881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85805B-A66D-46D6-8958-AD0A2E611CE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0395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85805B-A66D-46D6-8958-AD0A2E611CEF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98334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7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7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6" y="364072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1913472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7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235FFB-C8E9-4C04-ADC3-CD082A3725F0}" type="datetimeFigureOut">
              <a:rPr lang="en-AU" smtClean="0"/>
              <a:t>10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AC343-0C57-492F-AE66-F872D009AB71}" type="slidenum">
              <a:rPr lang="en-AU" smtClean="0"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jpeg"/><Relationship Id="rId18" Type="http://schemas.openxmlformats.org/officeDocument/2006/relationships/oleObject" Target="../embeddings/oleObject5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7.emf"/><Relationship Id="rId7" Type="http://schemas.openxmlformats.org/officeDocument/2006/relationships/image" Target="../media/image3.emf"/><Relationship Id="rId12" Type="http://schemas.openxmlformats.org/officeDocument/2006/relationships/image" Target="../media/image13.jpeg"/><Relationship Id="rId1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4.bin"/><Relationship Id="rId20" Type="http://schemas.openxmlformats.org/officeDocument/2006/relationships/oleObject" Target="../embeddings/oleObject6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2.jpeg"/><Relationship Id="rId5" Type="http://schemas.openxmlformats.org/officeDocument/2006/relationships/image" Target="../media/image2.emf"/><Relationship Id="rId15" Type="http://schemas.openxmlformats.org/officeDocument/2006/relationships/image" Target="../media/image4.emf"/><Relationship Id="rId23" Type="http://schemas.openxmlformats.org/officeDocument/2006/relationships/image" Target="../media/image8.emf"/><Relationship Id="rId10" Type="http://schemas.openxmlformats.org/officeDocument/2006/relationships/image" Target="../media/image11.png"/><Relationship Id="rId19" Type="http://schemas.openxmlformats.org/officeDocument/2006/relationships/image" Target="../media/image6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10.png"/><Relationship Id="rId14" Type="http://schemas.openxmlformats.org/officeDocument/2006/relationships/oleObject" Target="../embeddings/oleObject3.bin"/><Relationship Id="rId22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8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3400" y="3558598"/>
            <a:ext cx="5334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was lab chow diet (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Diet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10); HF-FD was high-fat (consisting of 315 g/kg from fat, 31.5% by weight) and fibre deficient (50g/kg from cellulose, low accessibility by gut microbiota with 5% by weight). Foods were made from semi-synthetic materials according to the recommendation of “AIN93 Diet for Laboratory Rodents”; HF-MAC was high-fat (consisting of 316 g/kg from fat, 31.6% by weight) and 634g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Diet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10 (plant polysaccharide-rich from a diverse source of plants including corn, soybean, wheat, oats, alfalfa and beet, neutral detergent fibre content is 10% by weight)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36935"/>
              </p:ext>
            </p:extLst>
          </p:nvPr>
        </p:nvGraphicFramePr>
        <p:xfrm>
          <a:off x="533400" y="838200"/>
          <a:ext cx="5884862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48" name="Document" r:id="rId3" imgW="5902245" imgH="3503897" progId="Word.Document.12">
                  <p:embed/>
                </p:oleObj>
              </mc:Choice>
              <mc:Fallback>
                <p:oleObj name="Document" r:id="rId3" imgW="5902245" imgH="3503897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3400" y="838200"/>
                        <a:ext cx="5884862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6949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79B8DAA2-5E6C-4B1E-A4B0-EDA0C18885FC}"/>
              </a:ext>
            </a:extLst>
          </p:cNvPr>
          <p:cNvGrpSpPr/>
          <p:nvPr/>
        </p:nvGrpSpPr>
        <p:grpSpPr>
          <a:xfrm>
            <a:off x="4920777" y="531077"/>
            <a:ext cx="1191098" cy="3001111"/>
            <a:chOff x="4790432" y="2241470"/>
            <a:chExt cx="1191098" cy="3001111"/>
          </a:xfrm>
        </p:grpSpPr>
        <p:sp>
          <p:nvSpPr>
            <p:cNvPr id="115" name="Rectangle 55">
              <a:extLst>
                <a:ext uri="{FF2B5EF4-FFF2-40B4-BE49-F238E27FC236}">
                  <a16:creationId xmlns:a16="http://schemas.microsoft.com/office/drawing/2014/main" id="{02995090-D37F-4B06-AC7E-80D723642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0432" y="2241470"/>
              <a:ext cx="2129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graphicFrame>
          <p:nvGraphicFramePr>
            <p:cNvPr id="87" name="对象 86">
              <a:extLst>
                <a:ext uri="{FF2B5EF4-FFF2-40B4-BE49-F238E27FC236}">
                  <a16:creationId xmlns:a16="http://schemas.microsoft.com/office/drawing/2014/main" id="{55CD8A4B-002B-4BFE-8005-CB486129D7F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4427166"/>
                </p:ext>
              </p:extLst>
            </p:nvPr>
          </p:nvGraphicFramePr>
          <p:xfrm>
            <a:off x="4806780" y="2510493"/>
            <a:ext cx="1174750" cy="27320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420" name="Prism 8" r:id="rId4" imgW="1175483" imgH="2732129" progId="Prism8.Document">
                    <p:embed/>
                  </p:oleObj>
                </mc:Choice>
                <mc:Fallback>
                  <p:oleObj name="Prism 8" r:id="rId4" imgW="1175483" imgH="2732129" progId="Prism8.Document">
                    <p:embed/>
                    <p:pic>
                      <p:nvPicPr>
                        <p:cNvPr id="87" name="对象 86">
                          <a:extLst>
                            <a:ext uri="{FF2B5EF4-FFF2-40B4-BE49-F238E27FC236}">
                              <a16:creationId xmlns:a16="http://schemas.microsoft.com/office/drawing/2014/main" id="{55CD8A4B-002B-4BFE-8005-CB486129D7F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806780" y="2510493"/>
                          <a:ext cx="1174750" cy="27320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86" name="对象 85">
            <a:extLst>
              <a:ext uri="{FF2B5EF4-FFF2-40B4-BE49-F238E27FC236}">
                <a16:creationId xmlns:a16="http://schemas.microsoft.com/office/drawing/2014/main" id="{3F224202-5ED3-4485-85B7-2E10488576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9963621"/>
              </p:ext>
            </p:extLst>
          </p:nvPr>
        </p:nvGraphicFramePr>
        <p:xfrm>
          <a:off x="4691063" y="2651125"/>
          <a:ext cx="1189037" cy="2757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421" name="Prism 8" r:id="rId6" imgW="1189168" imgH="2758060" progId="Prism8.Document">
                  <p:embed/>
                </p:oleObj>
              </mc:Choice>
              <mc:Fallback>
                <p:oleObj name="Prism 8" r:id="rId6" imgW="1189168" imgH="2758060" progId="Prism8.Document">
                  <p:embed/>
                  <p:pic>
                    <p:nvPicPr>
                      <p:cNvPr id="86" name="对象 85">
                        <a:extLst>
                          <a:ext uri="{FF2B5EF4-FFF2-40B4-BE49-F238E27FC236}">
                            <a16:creationId xmlns:a16="http://schemas.microsoft.com/office/drawing/2014/main" id="{3F224202-5ED3-4485-85B7-2E10488576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91063" y="2651125"/>
                        <a:ext cx="1189037" cy="2757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1" name="Rectangle 55">
            <a:extLst>
              <a:ext uri="{FF2B5EF4-FFF2-40B4-BE49-F238E27FC236}">
                <a16:creationId xmlns:a16="http://schemas.microsoft.com/office/drawing/2014/main" id="{A5D49A17-0602-4F48-BF5A-20703DC272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664" y="2491808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D2380805-292B-4078-BE44-96330A67B2AD}"/>
              </a:ext>
            </a:extLst>
          </p:cNvPr>
          <p:cNvGrpSpPr/>
          <p:nvPr/>
        </p:nvGrpSpPr>
        <p:grpSpPr>
          <a:xfrm>
            <a:off x="3331526" y="2919896"/>
            <a:ext cx="1399156" cy="1050904"/>
            <a:chOff x="3320708" y="2850319"/>
            <a:chExt cx="1399156" cy="1050904"/>
          </a:xfrm>
        </p:grpSpPr>
        <p:grpSp>
          <p:nvGrpSpPr>
            <p:cNvPr id="64" name="组合 99">
              <a:extLst>
                <a:ext uri="{FF2B5EF4-FFF2-40B4-BE49-F238E27FC236}">
                  <a16:creationId xmlns:a16="http://schemas.microsoft.com/office/drawing/2014/main" id="{5D90B3D9-2385-46E5-9E6D-EB26512C72A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320708" y="2850319"/>
              <a:ext cx="1399156" cy="1050904"/>
              <a:chOff x="3171642" y="2856436"/>
              <a:chExt cx="1864468" cy="1400635"/>
            </a:xfrm>
          </p:grpSpPr>
          <p:pic>
            <p:nvPicPr>
              <p:cNvPr id="66" name="图片 90">
                <a:extLst>
                  <a:ext uri="{FF2B5EF4-FFF2-40B4-BE49-F238E27FC236}">
                    <a16:creationId xmlns:a16="http://schemas.microsoft.com/office/drawing/2014/main" id="{CEEF3E56-0878-4C32-A6D2-5520A14B34E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51838" y="2856436"/>
                <a:ext cx="1784272" cy="13434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7" name="Rectangle 55">
                <a:extLst>
                  <a:ext uri="{FF2B5EF4-FFF2-40B4-BE49-F238E27FC236}">
                    <a16:creationId xmlns:a16="http://schemas.microsoft.com/office/drawing/2014/main" id="{3F3263AA-01A6-4AF2-8EE1-C02839763C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1642" y="3928910"/>
                <a:ext cx="1039865" cy="3281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-MAC</a:t>
                </a:r>
              </a:p>
            </p:txBody>
          </p:sp>
        </p:grpSp>
        <p:cxnSp>
          <p:nvCxnSpPr>
            <p:cNvPr id="92" name="直接连接符 91">
              <a:extLst>
                <a:ext uri="{FF2B5EF4-FFF2-40B4-BE49-F238E27FC236}">
                  <a16:creationId xmlns:a16="http://schemas.microsoft.com/office/drawing/2014/main" id="{C29065B4-C021-4BA2-89E4-DB0280ABFC6A}"/>
                </a:ext>
              </a:extLst>
            </p:cNvPr>
            <p:cNvCxnSpPr>
              <a:cxnSpLocks/>
            </p:cNvCxnSpPr>
            <p:nvPr/>
          </p:nvCxnSpPr>
          <p:spPr>
            <a:xfrm>
              <a:off x="4568413" y="3814130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A86875A0-D0CC-4CD6-90F7-559263A1F593}"/>
              </a:ext>
            </a:extLst>
          </p:cNvPr>
          <p:cNvGrpSpPr/>
          <p:nvPr/>
        </p:nvGrpSpPr>
        <p:grpSpPr>
          <a:xfrm>
            <a:off x="1945340" y="2925155"/>
            <a:ext cx="1386793" cy="1045649"/>
            <a:chOff x="1913256" y="2844945"/>
            <a:chExt cx="1386793" cy="1045649"/>
          </a:xfrm>
        </p:grpSpPr>
        <p:grpSp>
          <p:nvGrpSpPr>
            <p:cNvPr id="69" name="组合 98">
              <a:extLst>
                <a:ext uri="{FF2B5EF4-FFF2-40B4-BE49-F238E27FC236}">
                  <a16:creationId xmlns:a16="http://schemas.microsoft.com/office/drawing/2014/main" id="{CF655556-020F-4410-9542-29FAD66BDA8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13256" y="2844945"/>
              <a:ext cx="1386793" cy="1045649"/>
              <a:chOff x="1781199" y="2865994"/>
              <a:chExt cx="1850194" cy="1393695"/>
            </a:xfrm>
          </p:grpSpPr>
          <p:pic>
            <p:nvPicPr>
              <p:cNvPr id="71" name="图片 96">
                <a:extLst>
                  <a:ext uri="{FF2B5EF4-FFF2-40B4-BE49-F238E27FC236}">
                    <a16:creationId xmlns:a16="http://schemas.microsoft.com/office/drawing/2014/main" id="{718F66E7-47F7-4B94-B17D-26EC450F9C9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47038" y="2865994"/>
                <a:ext cx="1784355" cy="13435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2" name="Rectangle 55">
                <a:extLst>
                  <a:ext uri="{FF2B5EF4-FFF2-40B4-BE49-F238E27FC236}">
                    <a16:creationId xmlns:a16="http://schemas.microsoft.com/office/drawing/2014/main" id="{4FA95944-4EAC-4976-B9C8-4756B6B060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1199" y="3931513"/>
                <a:ext cx="763478" cy="328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-FD</a:t>
                </a:r>
              </a:p>
            </p:txBody>
          </p:sp>
        </p:grp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75A3B20D-64E9-475C-9FB7-D9B0AC93F74F}"/>
                </a:ext>
              </a:extLst>
            </p:cNvPr>
            <p:cNvCxnSpPr>
              <a:cxnSpLocks/>
            </p:cNvCxnSpPr>
            <p:nvPr/>
          </p:nvCxnSpPr>
          <p:spPr>
            <a:xfrm>
              <a:off x="3143647" y="3813026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EE0291C6-086A-4080-9168-929189A138FE}"/>
              </a:ext>
            </a:extLst>
          </p:cNvPr>
          <p:cNvGrpSpPr/>
          <p:nvPr/>
        </p:nvGrpSpPr>
        <p:grpSpPr>
          <a:xfrm>
            <a:off x="532897" y="2724392"/>
            <a:ext cx="1402979" cy="1257127"/>
            <a:chOff x="500813" y="2644182"/>
            <a:chExt cx="1402979" cy="1257127"/>
          </a:xfrm>
        </p:grpSpPr>
        <p:grpSp>
          <p:nvGrpSpPr>
            <p:cNvPr id="74" name="组合 100">
              <a:extLst>
                <a:ext uri="{FF2B5EF4-FFF2-40B4-BE49-F238E27FC236}">
                  <a16:creationId xmlns:a16="http://schemas.microsoft.com/office/drawing/2014/main" id="{1F4FD895-3D97-4A3B-9BA7-BB05A703AF9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00813" y="2644182"/>
              <a:ext cx="1402979" cy="1257127"/>
              <a:chOff x="607820" y="2820277"/>
              <a:chExt cx="1870599" cy="1676538"/>
            </a:xfrm>
          </p:grpSpPr>
          <p:sp>
            <p:nvSpPr>
              <p:cNvPr id="76" name="Rectangle 55">
                <a:extLst>
                  <a:ext uri="{FF2B5EF4-FFF2-40B4-BE49-F238E27FC236}">
                    <a16:creationId xmlns:a16="http://schemas.microsoft.com/office/drawing/2014/main" id="{F34D61E1-3819-42BE-80E6-C28DD2844D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7820" y="2820277"/>
                <a:ext cx="354904" cy="3283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  <a:sym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US" altLang="zh-CN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7" name="组合 97">
                <a:extLst>
                  <a:ext uri="{FF2B5EF4-FFF2-40B4-BE49-F238E27FC236}">
                    <a16:creationId xmlns:a16="http://schemas.microsoft.com/office/drawing/2014/main" id="{AA4B0C69-7510-463A-85F9-5E921520D0B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638178" y="3094512"/>
                <a:ext cx="1840241" cy="1402303"/>
                <a:chOff x="361529" y="2865995"/>
                <a:chExt cx="1840241" cy="1402303"/>
              </a:xfrm>
            </p:grpSpPr>
            <p:pic>
              <p:nvPicPr>
                <p:cNvPr id="78" name="图片 92">
                  <a:extLst>
                    <a:ext uri="{FF2B5EF4-FFF2-40B4-BE49-F238E27FC236}">
                      <a16:creationId xmlns:a16="http://schemas.microsoft.com/office/drawing/2014/main" id="{622E3E59-0920-4737-A4E1-F11BB75B209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16378" y="2865995"/>
                  <a:ext cx="1785392" cy="13442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9" name="Rectangle 55">
                  <a:extLst>
                    <a:ext uri="{FF2B5EF4-FFF2-40B4-BE49-F238E27FC236}">
                      <a16:creationId xmlns:a16="http://schemas.microsoft.com/office/drawing/2014/main" id="{044850C5-C802-411C-BFA8-C2B1DC8D93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529" y="3939931"/>
                  <a:ext cx="600538" cy="3283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  <a:sym typeface="Calibri" panose="020F050202020403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0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</a:p>
              </p:txBody>
            </p:sp>
          </p:grpSp>
        </p:grp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8CA3CD70-4E24-4F49-8E6E-6927FBE18E4F}"/>
                </a:ext>
              </a:extLst>
            </p:cNvPr>
            <p:cNvCxnSpPr>
              <a:cxnSpLocks/>
            </p:cNvCxnSpPr>
            <p:nvPr/>
          </p:nvCxnSpPr>
          <p:spPr>
            <a:xfrm>
              <a:off x="1762521" y="3823657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Rectangle 55">
            <a:extLst>
              <a:ext uri="{FF2B5EF4-FFF2-40B4-BE49-F238E27FC236}">
                <a16:creationId xmlns:a16="http://schemas.microsoft.com/office/drawing/2014/main" id="{D33F47A1-032D-4FF1-A3A0-BAEE8AFB20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6204" y="2488602"/>
            <a:ext cx="354937" cy="276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8EF4B47C-BEA2-4985-B1E8-AD3417A619A7}"/>
              </a:ext>
            </a:extLst>
          </p:cNvPr>
          <p:cNvGrpSpPr/>
          <p:nvPr/>
        </p:nvGrpSpPr>
        <p:grpSpPr>
          <a:xfrm>
            <a:off x="496855" y="4408693"/>
            <a:ext cx="4191000" cy="1415109"/>
            <a:chOff x="496670" y="4248512"/>
            <a:chExt cx="4191000" cy="1415109"/>
          </a:xfrm>
        </p:grpSpPr>
        <p:grpSp>
          <p:nvGrpSpPr>
            <p:cNvPr id="95" name="组合 12">
              <a:extLst>
                <a:ext uri="{FF2B5EF4-FFF2-40B4-BE49-F238E27FC236}">
                  <a16:creationId xmlns:a16="http://schemas.microsoft.com/office/drawing/2014/main" id="{CC640A37-A49D-459B-B383-2A5881A4893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96670" y="4248512"/>
              <a:ext cx="4191000" cy="1415109"/>
              <a:chOff x="492125" y="5283367"/>
              <a:chExt cx="4191199" cy="1415108"/>
            </a:xfrm>
          </p:grpSpPr>
          <p:pic>
            <p:nvPicPr>
              <p:cNvPr id="96" name="图片 6">
                <a:extLst>
                  <a:ext uri="{FF2B5EF4-FFF2-40B4-BE49-F238E27FC236}">
                    <a16:creationId xmlns:a16="http://schemas.microsoft.com/office/drawing/2014/main" id="{C1F000CD-F936-45F4-8E2A-5B7FF60D261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55841" y="5650899"/>
                <a:ext cx="1338750" cy="10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97" name="图片 4">
                <a:extLst>
                  <a:ext uri="{FF2B5EF4-FFF2-40B4-BE49-F238E27FC236}">
                    <a16:creationId xmlns:a16="http://schemas.microsoft.com/office/drawing/2014/main" id="{5D11C52D-A70D-46CE-973E-4EE064795DB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8461" y="5636485"/>
                <a:ext cx="1338750" cy="10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98" name="组合 11">
                <a:extLst>
                  <a:ext uri="{FF2B5EF4-FFF2-40B4-BE49-F238E27FC236}">
                    <a16:creationId xmlns:a16="http://schemas.microsoft.com/office/drawing/2014/main" id="{106A7035-1E94-4215-9F74-1F04111DC2E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92125" y="5283367"/>
                <a:ext cx="4191199" cy="1415108"/>
                <a:chOff x="492125" y="5283367"/>
                <a:chExt cx="4191199" cy="1415108"/>
              </a:xfrm>
            </p:grpSpPr>
            <p:pic>
              <p:nvPicPr>
                <p:cNvPr id="99" name="图片 10">
                  <a:extLst>
                    <a:ext uri="{FF2B5EF4-FFF2-40B4-BE49-F238E27FC236}">
                      <a16:creationId xmlns:a16="http://schemas.microsoft.com/office/drawing/2014/main" id="{F9412B1E-0AE6-40C9-AB32-F081422A070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344574" y="5657539"/>
                  <a:ext cx="1338750" cy="1008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00" name="组合 16">
                  <a:extLst>
                    <a:ext uri="{FF2B5EF4-FFF2-40B4-BE49-F238E27FC236}">
                      <a16:creationId xmlns:a16="http://schemas.microsoft.com/office/drawing/2014/main" id="{C03C3BE0-2A67-45C1-8CAE-BC615BA90CC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492125" y="5283367"/>
                  <a:ext cx="3546991" cy="1415108"/>
                  <a:chOff x="492797" y="5726236"/>
                  <a:chExt cx="3546496" cy="1416256"/>
                </a:xfrm>
              </p:grpSpPr>
              <p:grpSp>
                <p:nvGrpSpPr>
                  <p:cNvPr id="101" name="组合 3">
                    <a:extLst>
                      <a:ext uri="{FF2B5EF4-FFF2-40B4-BE49-F238E27FC236}">
                        <a16:creationId xmlns:a16="http://schemas.microsoft.com/office/drawing/2014/main" id="{AEDEFA60-ABBC-470C-9C05-89F59579B92A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516065" y="6877898"/>
                    <a:ext cx="3523228" cy="264594"/>
                    <a:chOff x="-1006725" y="7822412"/>
                    <a:chExt cx="3523228" cy="264594"/>
                  </a:xfrm>
                </p:grpSpPr>
                <p:sp>
                  <p:nvSpPr>
                    <p:cNvPr id="103" name="Rectangle 55">
                      <a:extLst>
                        <a:ext uri="{FF2B5EF4-FFF2-40B4-BE49-F238E27FC236}">
                          <a16:creationId xmlns:a16="http://schemas.microsoft.com/office/drawing/2014/main" id="{F7A8F54C-E445-4074-8EF0-E884A7FB27A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-1006725" y="7822412"/>
                      <a:ext cx="496565" cy="2462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9pPr>
                    </a:lstStyle>
                    <a:p>
                      <a:pPr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</a:t>
                      </a:r>
                    </a:p>
                  </p:txBody>
                </p:sp>
                <p:sp>
                  <p:nvSpPr>
                    <p:cNvPr id="104" name="Rectangle 55">
                      <a:extLst>
                        <a:ext uri="{FF2B5EF4-FFF2-40B4-BE49-F238E27FC236}">
                          <a16:creationId xmlns:a16="http://schemas.microsoft.com/office/drawing/2014/main" id="{7BCD5FC2-1EAC-45C1-913B-CA5403167F4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8717" y="7833701"/>
                      <a:ext cx="658049" cy="24642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9pPr>
                    </a:lstStyle>
                    <a:p>
                      <a:pPr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-FD</a:t>
                      </a:r>
                    </a:p>
                  </p:txBody>
                </p:sp>
                <p:sp>
                  <p:nvSpPr>
                    <p:cNvPr id="105" name="Rectangle 55">
                      <a:extLst>
                        <a:ext uri="{FF2B5EF4-FFF2-40B4-BE49-F238E27FC236}">
                          <a16:creationId xmlns:a16="http://schemas.microsoft.com/office/drawing/2014/main" id="{4B8CE710-0A95-4538-AE0C-125360EDB95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767812" y="7840586"/>
                      <a:ext cx="748691" cy="24642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  <a:sym typeface="Calibri" panose="020F0502020204030204" pitchFamily="34" charset="0"/>
                        </a:defRPr>
                      </a:lvl9pPr>
                    </a:lstStyle>
                    <a:p>
                      <a:pPr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1000" b="1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-MAC</a:t>
                      </a:r>
                    </a:p>
                  </p:txBody>
                </p:sp>
              </p:grpSp>
              <p:sp>
                <p:nvSpPr>
                  <p:cNvPr id="102" name="Rectangle 55">
                    <a:extLst>
                      <a:ext uri="{FF2B5EF4-FFF2-40B4-BE49-F238E27FC236}">
                        <a16:creationId xmlns:a16="http://schemas.microsoft.com/office/drawing/2014/main" id="{35242270-11E8-4E2A-AA47-1A155E554C2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92797" y="5726236"/>
                    <a:ext cx="354904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  <a:sym typeface="Calibri" panose="020F050202020403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12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</a:t>
                    </a:r>
                  </a:p>
                </p:txBody>
              </p:sp>
            </p:grpSp>
          </p:grpSp>
        </p:grp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9FA08DA5-D608-4AFB-9C68-654677586F23}"/>
                </a:ext>
              </a:extLst>
            </p:cNvPr>
            <p:cNvCxnSpPr>
              <a:cxnSpLocks/>
            </p:cNvCxnSpPr>
            <p:nvPr/>
          </p:nvCxnSpPr>
          <p:spPr>
            <a:xfrm>
              <a:off x="4530313" y="5585780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B13C35CE-90B4-48E3-9115-2AD40EB54352}"/>
                </a:ext>
              </a:extLst>
            </p:cNvPr>
            <p:cNvCxnSpPr>
              <a:cxnSpLocks/>
            </p:cNvCxnSpPr>
            <p:nvPr/>
          </p:nvCxnSpPr>
          <p:spPr>
            <a:xfrm>
              <a:off x="3139663" y="5585780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>
              <a:extLst>
                <a:ext uri="{FF2B5EF4-FFF2-40B4-BE49-F238E27FC236}">
                  <a16:creationId xmlns:a16="http://schemas.microsoft.com/office/drawing/2014/main" id="{5E416614-D672-4E3B-A084-C6B978FC0A74}"/>
                </a:ext>
              </a:extLst>
            </p:cNvPr>
            <p:cNvCxnSpPr>
              <a:cxnSpLocks/>
            </p:cNvCxnSpPr>
            <p:nvPr/>
          </p:nvCxnSpPr>
          <p:spPr>
            <a:xfrm>
              <a:off x="1768063" y="5566730"/>
              <a:ext cx="9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8314E979-B896-4F69-9B23-A76B61DD458E}"/>
              </a:ext>
            </a:extLst>
          </p:cNvPr>
          <p:cNvGrpSpPr/>
          <p:nvPr/>
        </p:nvGrpSpPr>
        <p:grpSpPr>
          <a:xfrm>
            <a:off x="479923" y="5982176"/>
            <a:ext cx="1179513" cy="2949930"/>
            <a:chOff x="2933263" y="6647629"/>
            <a:chExt cx="1179513" cy="2949930"/>
          </a:xfrm>
        </p:grpSpPr>
        <p:sp>
          <p:nvSpPr>
            <p:cNvPr id="5" name="Rectangle 55">
              <a:extLst>
                <a:ext uri="{FF2B5EF4-FFF2-40B4-BE49-F238E27FC236}">
                  <a16:creationId xmlns:a16="http://schemas.microsoft.com/office/drawing/2014/main" id="{ADBCC04D-2679-4C3A-9B35-188C79957C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2136" y="6647629"/>
              <a:ext cx="20716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</a:p>
          </p:txBody>
        </p:sp>
        <p:graphicFrame>
          <p:nvGraphicFramePr>
            <p:cNvPr id="83" name="对象 82">
              <a:extLst>
                <a:ext uri="{FF2B5EF4-FFF2-40B4-BE49-F238E27FC236}">
                  <a16:creationId xmlns:a16="http://schemas.microsoft.com/office/drawing/2014/main" id="{B4624E7A-EE5E-462B-B0D6-1F915745224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73665985"/>
                </p:ext>
              </p:extLst>
            </p:nvPr>
          </p:nvGraphicFramePr>
          <p:xfrm>
            <a:off x="2933263" y="6892459"/>
            <a:ext cx="1179513" cy="2705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422" name="Prism 8" r:id="rId14" imgW="1180165" imgH="2704757" progId="Prism8.Document">
                    <p:embed/>
                  </p:oleObj>
                </mc:Choice>
                <mc:Fallback>
                  <p:oleObj name="Prism 8" r:id="rId14" imgW="1180165" imgH="2704757" progId="Prism8.Document">
                    <p:embed/>
                    <p:pic>
                      <p:nvPicPr>
                        <p:cNvPr id="83" name="对象 82">
                          <a:extLst>
                            <a:ext uri="{FF2B5EF4-FFF2-40B4-BE49-F238E27FC236}">
                              <a16:creationId xmlns:a16="http://schemas.microsoft.com/office/drawing/2014/main" id="{B4624E7A-EE5E-462B-B0D6-1F915745224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933263" y="6892459"/>
                          <a:ext cx="1179513" cy="2705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93F33493-B62F-4314-A96E-54C07E17F3A4}"/>
              </a:ext>
            </a:extLst>
          </p:cNvPr>
          <p:cNvGrpSpPr/>
          <p:nvPr/>
        </p:nvGrpSpPr>
        <p:grpSpPr>
          <a:xfrm>
            <a:off x="1688272" y="5965485"/>
            <a:ext cx="1174750" cy="2975012"/>
            <a:chOff x="4431739" y="5901453"/>
            <a:chExt cx="1174750" cy="2975012"/>
          </a:xfrm>
        </p:grpSpPr>
        <p:sp>
          <p:nvSpPr>
            <p:cNvPr id="48" name="Rectangle 55">
              <a:extLst>
                <a:ext uri="{FF2B5EF4-FFF2-40B4-BE49-F238E27FC236}">
                  <a16:creationId xmlns:a16="http://schemas.microsoft.com/office/drawing/2014/main" id="{899B1C89-6451-4916-9B86-19AF4C825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9133" y="5901453"/>
              <a:ext cx="2129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</a:p>
          </p:txBody>
        </p:sp>
        <p:graphicFrame>
          <p:nvGraphicFramePr>
            <p:cNvPr id="84" name="对象 83">
              <a:extLst>
                <a:ext uri="{FF2B5EF4-FFF2-40B4-BE49-F238E27FC236}">
                  <a16:creationId xmlns:a16="http://schemas.microsoft.com/office/drawing/2014/main" id="{DB451421-8079-4B12-93DC-8666F464D8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0578649"/>
                </p:ext>
              </p:extLst>
            </p:nvPr>
          </p:nvGraphicFramePr>
          <p:xfrm>
            <a:off x="4431739" y="6171365"/>
            <a:ext cx="1174750" cy="2705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423" name="Prism 8" r:id="rId16" imgW="1175483" imgH="2704757" progId="Prism8.Document">
                    <p:embed/>
                  </p:oleObj>
                </mc:Choice>
                <mc:Fallback>
                  <p:oleObj name="Prism 8" r:id="rId16" imgW="1175483" imgH="2704757" progId="Prism8.Document">
                    <p:embed/>
                    <p:pic>
                      <p:nvPicPr>
                        <p:cNvPr id="84" name="对象 83">
                          <a:extLst>
                            <a:ext uri="{FF2B5EF4-FFF2-40B4-BE49-F238E27FC236}">
                              <a16:creationId xmlns:a16="http://schemas.microsoft.com/office/drawing/2014/main" id="{DB451421-8079-4B12-93DC-8666F464D8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431739" y="6171365"/>
                          <a:ext cx="1174750" cy="2705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17B8F4ED-D82F-4C09-8E40-655419F70A13}"/>
              </a:ext>
            </a:extLst>
          </p:cNvPr>
          <p:cNvGrpSpPr/>
          <p:nvPr/>
        </p:nvGrpSpPr>
        <p:grpSpPr>
          <a:xfrm>
            <a:off x="4664739" y="4411757"/>
            <a:ext cx="2054225" cy="2036387"/>
            <a:chOff x="4544352" y="4113920"/>
            <a:chExt cx="2054225" cy="2036387"/>
          </a:xfrm>
        </p:grpSpPr>
        <p:graphicFrame>
          <p:nvGraphicFramePr>
            <p:cNvPr id="91" name="对象 90">
              <a:extLst>
                <a:ext uri="{FF2B5EF4-FFF2-40B4-BE49-F238E27FC236}">
                  <a16:creationId xmlns:a16="http://schemas.microsoft.com/office/drawing/2014/main" id="{A3BD7F78-11C2-4C4D-BC46-A8D1FE5AE2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88598254"/>
                </p:ext>
              </p:extLst>
            </p:nvPr>
          </p:nvGraphicFramePr>
          <p:xfrm>
            <a:off x="4544352" y="4207207"/>
            <a:ext cx="2054225" cy="1943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424" name="Prism 8" r:id="rId18" imgW="2053494" imgH="1942311" progId="Prism8.Document">
                    <p:embed/>
                  </p:oleObj>
                </mc:Choice>
                <mc:Fallback>
                  <p:oleObj name="Prism 8" r:id="rId18" imgW="2053494" imgH="1942311" progId="Prism8.Document">
                    <p:embed/>
                    <p:pic>
                      <p:nvPicPr>
                        <p:cNvPr id="91" name="对象 90">
                          <a:extLst>
                            <a:ext uri="{FF2B5EF4-FFF2-40B4-BE49-F238E27FC236}">
                              <a16:creationId xmlns:a16="http://schemas.microsoft.com/office/drawing/2014/main" id="{A3BD7F78-11C2-4C4D-BC46-A8D1FE5AE2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4544352" y="4207207"/>
                          <a:ext cx="2054225" cy="1943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1" name="Rectangle 55">
              <a:extLst>
                <a:ext uri="{FF2B5EF4-FFF2-40B4-BE49-F238E27FC236}">
                  <a16:creationId xmlns:a16="http://schemas.microsoft.com/office/drawing/2014/main" id="{13693DB6-1D94-4F47-B50C-0E4C06DC8D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3668" y="4113920"/>
              <a:ext cx="354937" cy="276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</p:grpSp>
      <p:sp>
        <p:nvSpPr>
          <p:cNvPr id="58" name="矩形 57">
            <a:extLst>
              <a:ext uri="{FF2B5EF4-FFF2-40B4-BE49-F238E27FC236}">
                <a16:creationId xmlns:a16="http://schemas.microsoft.com/office/drawing/2014/main" id="{ECBC8144-B87B-4EAC-9510-0857FE898C39}"/>
              </a:ext>
            </a:extLst>
          </p:cNvPr>
          <p:cNvSpPr/>
          <p:nvPr/>
        </p:nvSpPr>
        <p:spPr>
          <a:xfrm>
            <a:off x="160765" y="169822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 S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55">
            <a:extLst>
              <a:ext uri="{FF2B5EF4-FFF2-40B4-BE49-F238E27FC236}">
                <a16:creationId xmlns:a16="http://schemas.microsoft.com/office/drawing/2014/main" id="{86164D1B-41B0-4329-8AF7-CE0E94D9AD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8670" y="529833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1" name="对象 51">
            <a:extLst>
              <a:ext uri="{FF2B5EF4-FFF2-40B4-BE49-F238E27FC236}">
                <a16:creationId xmlns:a16="http://schemas.microsoft.com/office/drawing/2014/main" id="{017DD3A3-138A-4BF0-84A6-51A4EDD953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1434038"/>
              </p:ext>
            </p:extLst>
          </p:nvPr>
        </p:nvGraphicFramePr>
        <p:xfrm>
          <a:off x="496855" y="763456"/>
          <a:ext cx="2471738" cy="17252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425" name="Prism 8" r:id="rId20" imgW="3526449" imgH="2460933" progId="Prism8.Document">
                  <p:embed/>
                </p:oleObj>
              </mc:Choice>
              <mc:Fallback>
                <p:oleObj name="Prism 8" r:id="rId20" imgW="3526449" imgH="2460933" progId="Prism8.Document">
                  <p:embed/>
                  <p:pic>
                    <p:nvPicPr>
                      <p:cNvPr id="11" name="对象 51">
                        <a:extLst>
                          <a:ext uri="{FF2B5EF4-FFF2-40B4-BE49-F238E27FC236}">
                            <a16:creationId xmlns:a16="http://schemas.microsoft.com/office/drawing/2014/main" id="{017DD3A3-138A-4BF0-84A6-51A4EDD9537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6855" y="763456"/>
                        <a:ext cx="2471738" cy="172521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Rectangle 55">
            <a:extLst>
              <a:ext uri="{FF2B5EF4-FFF2-40B4-BE49-F238E27FC236}">
                <a16:creationId xmlns:a16="http://schemas.microsoft.com/office/drawing/2014/main" id="{E72B22F1-F070-4124-9104-C1F508817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966" y="538522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68" name="对象 67">
            <a:extLst>
              <a:ext uri="{FF2B5EF4-FFF2-40B4-BE49-F238E27FC236}">
                <a16:creationId xmlns:a16="http://schemas.microsoft.com/office/drawing/2014/main" id="{13B790A3-65BF-42D6-B221-F833C9AAE6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7159520"/>
              </p:ext>
            </p:extLst>
          </p:nvPr>
        </p:nvGraphicFramePr>
        <p:xfrm>
          <a:off x="2813050" y="735013"/>
          <a:ext cx="2228850" cy="1830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426" name="Prism 8" r:id="rId22" imgW="2228880" imgH="1831023" progId="Prism8.Document">
                  <p:embed/>
                </p:oleObj>
              </mc:Choice>
              <mc:Fallback>
                <p:oleObj name="Prism 8" r:id="rId22" imgW="2228880" imgH="1831023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171C10A3-2E24-4475-8532-FB898AB278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813050" y="735013"/>
                        <a:ext cx="2228850" cy="1830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4030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646BB4EE-5BB6-46DA-B651-77A411B002C2}"/>
              </a:ext>
            </a:extLst>
          </p:cNvPr>
          <p:cNvGrpSpPr/>
          <p:nvPr/>
        </p:nvGrpSpPr>
        <p:grpSpPr>
          <a:xfrm>
            <a:off x="489087" y="576151"/>
            <a:ext cx="2913063" cy="2267052"/>
            <a:chOff x="2823535" y="5885931"/>
            <a:chExt cx="2913063" cy="2267052"/>
          </a:xfrm>
        </p:grpSpPr>
        <p:graphicFrame>
          <p:nvGraphicFramePr>
            <p:cNvPr id="8" name="对象 7">
              <a:extLst>
                <a:ext uri="{FF2B5EF4-FFF2-40B4-BE49-F238E27FC236}">
                  <a16:creationId xmlns:a16="http://schemas.microsoft.com/office/drawing/2014/main" id="{1A7935C9-FF45-4FD6-9825-6D2F724080D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34475265"/>
                </p:ext>
              </p:extLst>
            </p:nvPr>
          </p:nvGraphicFramePr>
          <p:xfrm>
            <a:off x="2823535" y="6011446"/>
            <a:ext cx="2913063" cy="21415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2824" name="Prism 8" r:id="rId3" imgW="2913498" imgH="2140756" progId="Prism8.Document">
                    <p:embed/>
                  </p:oleObj>
                </mc:Choice>
                <mc:Fallback>
                  <p:oleObj name="Prism 8" r:id="rId3" imgW="2913498" imgH="2140756" progId="Prism8.Document">
                    <p:embed/>
                    <p:pic>
                      <p:nvPicPr>
                        <p:cNvPr id="107" name="对象 106">
                          <a:extLst>
                            <a:ext uri="{FF2B5EF4-FFF2-40B4-BE49-F238E27FC236}">
                              <a16:creationId xmlns:a16="http://schemas.microsoft.com/office/drawing/2014/main" id="{867C3C57-1C83-48C7-864C-7CAF4CC7DA9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823535" y="6011446"/>
                          <a:ext cx="2913063" cy="21415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Rectangle 55">
              <a:extLst>
                <a:ext uri="{FF2B5EF4-FFF2-40B4-BE49-F238E27FC236}">
                  <a16:creationId xmlns:a16="http://schemas.microsoft.com/office/drawing/2014/main" id="{31ABE119-8555-4FB0-913E-0E743FBB45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7997" y="5885931"/>
              <a:ext cx="2129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63E58D88-353B-4517-9F23-FC5626FB1340}"/>
              </a:ext>
            </a:extLst>
          </p:cNvPr>
          <p:cNvGrpSpPr/>
          <p:nvPr/>
        </p:nvGrpSpPr>
        <p:grpSpPr>
          <a:xfrm>
            <a:off x="3311127" y="589583"/>
            <a:ext cx="1204913" cy="3119452"/>
            <a:chOff x="3478767" y="589583"/>
            <a:chExt cx="1204913" cy="3119452"/>
          </a:xfrm>
        </p:grpSpPr>
        <p:graphicFrame>
          <p:nvGraphicFramePr>
            <p:cNvPr id="6" name="对象 5">
              <a:extLst>
                <a:ext uri="{FF2B5EF4-FFF2-40B4-BE49-F238E27FC236}">
                  <a16:creationId xmlns:a16="http://schemas.microsoft.com/office/drawing/2014/main" id="{58BEAB70-F718-4495-B992-EBE1F193BD6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94935570"/>
                </p:ext>
              </p:extLst>
            </p:nvPr>
          </p:nvGraphicFramePr>
          <p:xfrm>
            <a:off x="3478767" y="1003935"/>
            <a:ext cx="1204913" cy="2705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2825" name="Prism 8" r:id="rId5" imgW="1204294" imgH="2704757" progId="Prism8.Document">
                    <p:embed/>
                  </p:oleObj>
                </mc:Choice>
                <mc:Fallback>
                  <p:oleObj name="Prism 8" r:id="rId5" imgW="1204294" imgH="2704757" progId="Prism8.Document">
                    <p:embed/>
                    <p:pic>
                      <p:nvPicPr>
                        <p:cNvPr id="85" name="对象 84">
                          <a:extLst>
                            <a:ext uri="{FF2B5EF4-FFF2-40B4-BE49-F238E27FC236}">
                              <a16:creationId xmlns:a16="http://schemas.microsoft.com/office/drawing/2014/main" id="{8CF1FE0C-95CD-42D9-9117-C65CB798D9E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478767" y="1003935"/>
                          <a:ext cx="1204913" cy="2705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Rectangle 55">
              <a:extLst>
                <a:ext uri="{FF2B5EF4-FFF2-40B4-BE49-F238E27FC236}">
                  <a16:creationId xmlns:a16="http://schemas.microsoft.com/office/drawing/2014/main" id="{BD9CBAE3-3357-4497-9125-236A58AD0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1735" y="589583"/>
              <a:ext cx="2129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  <a:sym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</a:p>
          </p:txBody>
        </p:sp>
      </p:grpSp>
      <p:sp>
        <p:nvSpPr>
          <p:cNvPr id="10" name="Rectangle 3">
            <a:extLst>
              <a:ext uri="{FF2B5EF4-FFF2-40B4-BE49-F238E27FC236}">
                <a16:creationId xmlns:a16="http://schemas.microsoft.com/office/drawing/2014/main" id="{9F4DFEF7-6F49-45D7-B191-FC8939352707}"/>
              </a:ext>
            </a:extLst>
          </p:cNvPr>
          <p:cNvSpPr/>
          <p:nvPr/>
        </p:nvSpPr>
        <p:spPr>
          <a:xfrm>
            <a:off x="565704" y="2843203"/>
            <a:ext cx="5803209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High-fat and fibre-deficient (HF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) diet induced metabolic syndrome in mice, which were to some degree attenuated by MAC supplementation.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ody weight over time (n=15). (B) Fat pad weight (n=9). (C) liver mass(n=9). (D and E) Representative images of hematoxylin and eosin (H&amp;E)-stained visceral adipose tissues and quantification of crown-like structures (CLS; n=5 images per mouse, n=6) in visceral adipose tissues. (F and G) Representative images of H&amp;E-stained liver tissues and index of hepatic cellular ballooning and steatosis (n=5 images per mouse, n=3). (H) Serum insulin (n=10). (I) Homeostatic model assessment-insulin resistance (HOMA-IR) index (n=10). (J) Glucose tolerance test with blood glucose levels were measured at the indicated time point and area under curve (AUC) (K) calculated (n=10). Values are mean ± SEM (B-I). </a:t>
            </a:r>
            <a:r>
              <a:rPr lang="en-AU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H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 vs. Control (Con). </a:t>
            </a:r>
            <a:r>
              <a:rPr lang="en-AU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5 H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AC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HF-FD. </a:t>
            </a:r>
            <a:r>
              <a:rPr lang="en-AU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$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5 HF-MAC vs. Con. Scale bar: 50μm.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didymal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ite adipose tissue;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WAT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guinal white adipose tissue;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BAT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scapular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own adipose tissue. </a:t>
            </a:r>
          </a:p>
        </p:txBody>
      </p:sp>
    </p:spTree>
    <p:extLst>
      <p:ext uri="{BB962C8B-B14F-4D97-AF65-F5344CB8AC3E}">
        <p14:creationId xmlns:p14="http://schemas.microsoft.com/office/powerpoint/2010/main" val="19654348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C8C5D52A-0E17-446E-B982-4A4F2071850B}"/>
              </a:ext>
            </a:extLst>
          </p:cNvPr>
          <p:cNvSpPr/>
          <p:nvPr/>
        </p:nvSpPr>
        <p:spPr>
          <a:xfrm>
            <a:off x="160765" y="169822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 S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0CD64592-72AB-460B-8226-568D588F2F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0086188"/>
              </p:ext>
            </p:extLst>
          </p:nvPr>
        </p:nvGraphicFramePr>
        <p:xfrm>
          <a:off x="4302006" y="957803"/>
          <a:ext cx="2320925" cy="1782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850" name="Prism 8" r:id="rId3" imgW="2320354" imgH="1782402" progId="Prism8.Document">
                  <p:embed/>
                </p:oleObj>
              </mc:Choice>
              <mc:Fallback>
                <p:oleObj name="Prism 8" r:id="rId3" imgW="2320354" imgH="1782402" progId="Prism8.Document">
                  <p:embed/>
                  <p:pic>
                    <p:nvPicPr>
                      <p:cNvPr id="58" name="对象 57">
                        <a:extLst>
                          <a:ext uri="{FF2B5EF4-FFF2-40B4-BE49-F238E27FC236}">
                            <a16:creationId xmlns:a16="http://schemas.microsoft.com/office/drawing/2014/main" id="{F030F660-7BE7-4D25-8892-DE53562281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02006" y="957803"/>
                        <a:ext cx="2320925" cy="1782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4722A072-3AF7-425D-9D8D-F6A2B8C0DC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8661778"/>
              </p:ext>
            </p:extLst>
          </p:nvPr>
        </p:nvGraphicFramePr>
        <p:xfrm>
          <a:off x="322101" y="787228"/>
          <a:ext cx="2382837" cy="2039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851" name="Prism 8" r:id="rId5" imgW="2383018" imgH="2039912" progId="Prism8.Document">
                  <p:embed/>
                </p:oleObj>
              </mc:Choice>
              <mc:Fallback>
                <p:oleObj name="Prism 8" r:id="rId5" imgW="2383018" imgH="2039912" progId="Prism8.Document">
                  <p:embed/>
                  <p:pic>
                    <p:nvPicPr>
                      <p:cNvPr id="74" name="对象 73">
                        <a:extLst>
                          <a:ext uri="{FF2B5EF4-FFF2-40B4-BE49-F238E27FC236}">
                            <a16:creationId xmlns:a16="http://schemas.microsoft.com/office/drawing/2014/main" id="{2762248A-FE59-4249-89BD-E7077FAB25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2101" y="787228"/>
                        <a:ext cx="2382837" cy="2039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23B6C812-16DD-4847-A539-ADC6FD510B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558009"/>
              </p:ext>
            </p:extLst>
          </p:nvPr>
        </p:nvGraphicFramePr>
        <p:xfrm>
          <a:off x="2328588" y="771190"/>
          <a:ext cx="2382837" cy="2039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852" name="Prism 8" r:id="rId7" imgW="2383018" imgH="2039912" progId="Prism8.Document">
                  <p:embed/>
                </p:oleObj>
              </mc:Choice>
              <mc:Fallback>
                <p:oleObj name="Prism 8" r:id="rId7" imgW="2383018" imgH="2039912" progId="Prism8.Document">
                  <p:embed/>
                  <p:pic>
                    <p:nvPicPr>
                      <p:cNvPr id="75" name="对象 74">
                        <a:extLst>
                          <a:ext uri="{FF2B5EF4-FFF2-40B4-BE49-F238E27FC236}">
                            <a16:creationId xmlns:a16="http://schemas.microsoft.com/office/drawing/2014/main" id="{9038DD6B-24DD-4D2E-AD2C-5B74157F02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28588" y="771190"/>
                        <a:ext cx="2382837" cy="2039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55">
            <a:extLst>
              <a:ext uri="{FF2B5EF4-FFF2-40B4-BE49-F238E27FC236}">
                <a16:creationId xmlns:a16="http://schemas.microsoft.com/office/drawing/2014/main" id="{84FCDC32-2B59-41D2-A4B9-555838A099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455" y="638989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Rectangle 55">
            <a:extLst>
              <a:ext uri="{FF2B5EF4-FFF2-40B4-BE49-F238E27FC236}">
                <a16:creationId xmlns:a16="http://schemas.microsoft.com/office/drawing/2014/main" id="{EAA4391C-A6DE-477A-81C0-DF704842DB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8588" y="638988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Rectangle 55">
            <a:extLst>
              <a:ext uri="{FF2B5EF4-FFF2-40B4-BE49-F238E27FC236}">
                <a16:creationId xmlns:a16="http://schemas.microsoft.com/office/drawing/2014/main" id="{4A533D71-D46D-4470-9148-552D6509F0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8206" y="648728"/>
            <a:ext cx="2129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  <a:sym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0" name="Rectangle 3">
            <a:extLst>
              <a:ext uri="{FF2B5EF4-FFF2-40B4-BE49-F238E27FC236}">
                <a16:creationId xmlns:a16="http://schemas.microsoft.com/office/drawing/2014/main" id="{BF3F8175-96DB-4FF6-ABBC-AA99D0084135}"/>
              </a:ext>
            </a:extLst>
          </p:cNvPr>
          <p:cNvSpPr/>
          <p:nvPr/>
        </p:nvSpPr>
        <p:spPr>
          <a:xfrm>
            <a:off x="565704" y="2843203"/>
            <a:ext cx="580320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et rich in microbiota-accessible carbohydrate prevented cognitive impairment in diet-induced obese mic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levels of gut Proteobacteria and the nest score (A), untorn nesting material (B), or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rimination ratio (C), Values are mean ± SEM. 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8455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CDBF3C28-FE64-4EA9-86B9-B1C1E289F3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5519690"/>
              </p:ext>
            </p:extLst>
          </p:nvPr>
        </p:nvGraphicFramePr>
        <p:xfrm>
          <a:off x="2586733" y="976875"/>
          <a:ext cx="1212850" cy="2292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773" name="Prism 8" r:id="rId3" imgW="1212217" imgH="2293101" progId="Prism8.Document">
                  <p:embed/>
                </p:oleObj>
              </mc:Choice>
              <mc:Fallback>
                <p:oleObj name="Prism 8" r:id="rId3" imgW="1212217" imgH="2293101" progId="Prism8.Document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515546B8-B9E6-4DAF-9046-E154E4585D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86733" y="976875"/>
                        <a:ext cx="1212850" cy="2292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id="{878D95B8-6FF7-41A7-AC7B-D84F4581E730}"/>
              </a:ext>
            </a:extLst>
          </p:cNvPr>
          <p:cNvSpPr/>
          <p:nvPr/>
        </p:nvSpPr>
        <p:spPr>
          <a:xfrm>
            <a:off x="537674" y="2910927"/>
            <a:ext cx="556541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AU" altLang="zh-CN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Levels of bacterial DNA in faeces were quantitated by qPCR after antibiotic (AB) treatment. </a:t>
            </a:r>
            <a:r>
              <a:rPr lang="en-AU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Values are mean ± SEM. n=6. </a:t>
            </a:r>
            <a:r>
              <a:rPr lang="en-AU" altLang="zh-CN" sz="1200" kern="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*</a:t>
            </a:r>
            <a:r>
              <a:rPr lang="en-AU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 </a:t>
            </a:r>
            <a:r>
              <a:rPr lang="en-AU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&lt; 0.05 vs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Control</a:t>
            </a:r>
            <a:r>
              <a:rPr lang="en-AU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(Con). </a:t>
            </a:r>
            <a:endParaRPr lang="zh-CN" altLang="en-US" sz="1200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FF0DF716-C502-4131-9BEF-C07D390295A6}"/>
              </a:ext>
            </a:extLst>
          </p:cNvPr>
          <p:cNvSpPr/>
          <p:nvPr/>
        </p:nvSpPr>
        <p:spPr>
          <a:xfrm>
            <a:off x="160765" y="169822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 S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197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344</TotalTime>
  <Words>498</Words>
  <Application>Microsoft Office PowerPoint</Application>
  <PresentationFormat>On-screen Show (4:3)</PresentationFormat>
  <Paragraphs>28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Document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Wollong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 Zhang</dc:creator>
  <cp:lastModifiedBy>Yinghua Yu</cp:lastModifiedBy>
  <cp:revision>1952</cp:revision>
  <dcterms:created xsi:type="dcterms:W3CDTF">2015-10-28T23:04:00Z</dcterms:created>
  <dcterms:modified xsi:type="dcterms:W3CDTF">2020-02-10T08:5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412</vt:lpwstr>
  </property>
</Properties>
</file>